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906000" type="A4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0" d="100"/>
          <a:sy n="70" d="100"/>
        </p:scale>
        <p:origin x="-1716" y="-2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34DA3A-CB18-45BB-99F2-DF0982122F2C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454791-7634-4557-99EB-A7B7BEEAE8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5081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C0EA9-EBD2-47A9-81D9-503240DDD785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BA5A8-578A-4EE1-8D2F-2EF455AFC5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8426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C0EA9-EBD2-47A9-81D9-503240DDD785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BA5A8-578A-4EE1-8D2F-2EF455AFC5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1528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C0EA9-EBD2-47A9-81D9-503240DDD785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BA5A8-578A-4EE1-8D2F-2EF455AFC5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5081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C0EA9-EBD2-47A9-81D9-503240DDD785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BA5A8-578A-4EE1-8D2F-2EF455AFC5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9148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C0EA9-EBD2-47A9-81D9-503240DDD785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BA5A8-578A-4EE1-8D2F-2EF455AFC5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5512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C0EA9-EBD2-47A9-81D9-503240DDD785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BA5A8-578A-4EE1-8D2F-2EF455AFC5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2498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C0EA9-EBD2-47A9-81D9-503240DDD785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BA5A8-578A-4EE1-8D2F-2EF455AFC5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0127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C0EA9-EBD2-47A9-81D9-503240DDD785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BA5A8-578A-4EE1-8D2F-2EF455AFC5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8287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C0EA9-EBD2-47A9-81D9-503240DDD785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BA5A8-578A-4EE1-8D2F-2EF455AFC5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1555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C0EA9-EBD2-47A9-81D9-503240DDD785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BA5A8-578A-4EE1-8D2F-2EF455AFC5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8968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C0EA9-EBD2-47A9-81D9-503240DDD785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BA5A8-578A-4EE1-8D2F-2EF455AFC5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4558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FC0EA9-EBD2-47A9-81D9-503240DDD785}" type="datetimeFigureOut">
              <a:rPr lang="de-DE" smtClean="0"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7BA5A8-578A-4EE1-8D2F-2EF455AFC5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8009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pieren 13"/>
          <p:cNvGrpSpPr/>
          <p:nvPr/>
        </p:nvGrpSpPr>
        <p:grpSpPr>
          <a:xfrm>
            <a:off x="1060157" y="247471"/>
            <a:ext cx="4940994" cy="2560789"/>
            <a:chOff x="1080294" y="1079999"/>
            <a:chExt cx="4940994" cy="2560789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80" t="25031" r="19234" b="31638"/>
            <a:stretch/>
          </p:blipFill>
          <p:spPr>
            <a:xfrm>
              <a:off x="1080294" y="1079999"/>
              <a:ext cx="4940994" cy="2560789"/>
            </a:xfrm>
            <a:prstGeom prst="rect">
              <a:avLst/>
            </a:prstGeom>
          </p:spPr>
        </p:pic>
        <p:sp>
          <p:nvSpPr>
            <p:cNvPr id="3" name="Textfeld 2"/>
            <p:cNvSpPr txBox="1"/>
            <p:nvPr/>
          </p:nvSpPr>
          <p:spPr>
            <a:xfrm>
              <a:off x="1080294" y="1079999"/>
              <a:ext cx="5501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x40</a:t>
              </a:r>
              <a:endParaRPr lang="de-DE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" name="Gerade Verbindung 3"/>
            <p:cNvCxnSpPr/>
            <p:nvPr/>
          </p:nvCxnSpPr>
          <p:spPr>
            <a:xfrm>
              <a:off x="1217986" y="3501807"/>
              <a:ext cx="259200" cy="0"/>
            </a:xfrm>
            <a:prstGeom prst="line">
              <a:avLst/>
            </a:prstGeom>
            <a:ln w="27305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Gruppieren 14"/>
          <p:cNvGrpSpPr/>
          <p:nvPr/>
        </p:nvGrpSpPr>
        <p:grpSpPr>
          <a:xfrm>
            <a:off x="1054958" y="3028027"/>
            <a:ext cx="4944748" cy="2309370"/>
            <a:chOff x="1054958" y="4085437"/>
            <a:chExt cx="4944748" cy="2309370"/>
          </a:xfrm>
        </p:grpSpPr>
        <p:pic>
          <p:nvPicPr>
            <p:cNvPr id="6" name="Grafik 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48" t="27779" r="20778" b="33567"/>
            <a:stretch/>
          </p:blipFill>
          <p:spPr>
            <a:xfrm>
              <a:off x="1060157" y="4088904"/>
              <a:ext cx="4939549" cy="2305903"/>
            </a:xfrm>
            <a:prstGeom prst="rect">
              <a:avLst/>
            </a:prstGeom>
          </p:spPr>
        </p:pic>
        <p:sp>
          <p:nvSpPr>
            <p:cNvPr id="7" name="Textfeld 6"/>
            <p:cNvSpPr txBox="1"/>
            <p:nvPr/>
          </p:nvSpPr>
          <p:spPr>
            <a:xfrm>
              <a:off x="1054958" y="4085437"/>
              <a:ext cx="5501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x43</a:t>
              </a:r>
              <a:endParaRPr lang="de-DE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Gerade Verbindung 7"/>
            <p:cNvCxnSpPr/>
            <p:nvPr/>
          </p:nvCxnSpPr>
          <p:spPr>
            <a:xfrm>
              <a:off x="1181278" y="6238111"/>
              <a:ext cx="298800" cy="0"/>
            </a:xfrm>
            <a:prstGeom prst="line">
              <a:avLst/>
            </a:prstGeom>
            <a:ln w="27305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Gruppieren 15"/>
          <p:cNvGrpSpPr/>
          <p:nvPr/>
        </p:nvGrpSpPr>
        <p:grpSpPr>
          <a:xfrm>
            <a:off x="1060157" y="5560632"/>
            <a:ext cx="4941288" cy="2616309"/>
            <a:chOff x="1098052" y="6969224"/>
            <a:chExt cx="4941288" cy="2616309"/>
          </a:xfrm>
        </p:grpSpPr>
        <p:pic>
          <p:nvPicPr>
            <p:cNvPr id="10" name="Grafik 9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26" t="19401" r="20856" b="36491"/>
            <a:stretch/>
          </p:blipFill>
          <p:spPr>
            <a:xfrm>
              <a:off x="1098052" y="6969224"/>
              <a:ext cx="4941288" cy="2616309"/>
            </a:xfrm>
            <a:prstGeom prst="rect">
              <a:avLst/>
            </a:prstGeom>
          </p:spPr>
        </p:pic>
        <p:sp>
          <p:nvSpPr>
            <p:cNvPr id="11" name="Textfeld 10"/>
            <p:cNvSpPr txBox="1"/>
            <p:nvPr/>
          </p:nvSpPr>
          <p:spPr>
            <a:xfrm>
              <a:off x="1098052" y="6969224"/>
              <a:ext cx="5501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x45</a:t>
              </a:r>
              <a:endParaRPr lang="de-DE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Gerade Verbindung 11"/>
            <p:cNvCxnSpPr/>
            <p:nvPr/>
          </p:nvCxnSpPr>
          <p:spPr>
            <a:xfrm>
              <a:off x="1204277" y="9478470"/>
              <a:ext cx="259200" cy="0"/>
            </a:xfrm>
            <a:prstGeom prst="line">
              <a:avLst/>
            </a:prstGeom>
            <a:ln w="27305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Textfeld 17"/>
          <p:cNvSpPr txBox="1"/>
          <p:nvPr/>
        </p:nvSpPr>
        <p:spPr>
          <a:xfrm>
            <a:off x="1054956" y="8256335"/>
            <a:ext cx="494474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Fig.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: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age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mal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istanc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terie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sualizatio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rna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lastic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min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nexin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x40, Cx43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x45 (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tly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-localized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ith the small holes (dark dots) within the internal elastic lamina (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autofluorescenc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green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ar: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µm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598" y="9578751"/>
            <a:ext cx="19732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833625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2</Words>
  <Application>Microsoft Office PowerPoint</Application>
  <PresentationFormat>A4-Papier (210x297 mm)</PresentationFormat>
  <Paragraphs>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meritsch</dc:creator>
  <cp:lastModifiedBy>Kameritsch</cp:lastModifiedBy>
  <cp:revision>24</cp:revision>
  <cp:lastPrinted>2014-03-07T09:17:11Z</cp:lastPrinted>
  <dcterms:created xsi:type="dcterms:W3CDTF">2014-02-26T08:59:49Z</dcterms:created>
  <dcterms:modified xsi:type="dcterms:W3CDTF">2014-03-10T10:49:04Z</dcterms:modified>
</cp:coreProperties>
</file>